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webextensions/webextension2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2959586-AF68-E9C7-F5A9-A02C8780D424}" name="Anushka Ataullahjan" initials="AA" userId="S::anushka.ataullahjan@utoronto.ca::9409acc5-d7ec-4cd4-9537-55a668d8a3b8" providerId="AD"/>
  <p188:author id="{A5720EE5-B781-93BA-0C1B-B1315E532697}" name="Erica Di Ruggiero" initials="ER" userId="S::e.diruggiero@utoronto.ca::087805d8-434b-4ae6-8212-1e6754a4538f" providerId="AD"/>
  <p188:author id="{3E51FBEC-F9A1-3339-68DA-8B773A98503D}" name="Shaza Fadel" initials="SF" userId="S::shaza.fadel@utoronto.ca::5d78bb4f-e5e9-4721-ad47-4d0ebd33044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AD578DF-2214-7921-FCF3-D4551027B9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A74A4749-46BA-D44F-1A78-7DC62813C9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1233B58-3DB5-C7C5-756E-A8E99B41EA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D8CD0BD-9D77-AC9A-52DE-1C4F6D92A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7E57B5C-A6DA-6651-E279-0B176BA743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6549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F4BE300-7991-6D13-62A2-B2F7C63316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E2F2E8EA-2038-2AA7-EC56-F18BBD0967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97D8674-57EC-8A27-4B5F-B9832E77E1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1CA1465-D487-27F4-20FE-BA54BE63C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174A11B-AF27-B93C-2AEF-B67CD0DFB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6068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FF1B637C-E952-63F8-9F10-A5787B9B6F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748FB03-AC90-88C7-3278-595E5E21A9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2C30466-8622-E963-8EC0-A8C603D50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77FC82C-B84B-C566-8B0D-87A8E9B32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2BA2199-C705-496F-210D-E610DCF47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0193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DB34AC3-05DB-030C-CFF2-E2FA0F610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3A141BD-3069-73CF-57B7-B0F458646B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BF7682C-FE66-B39C-18D4-39396C373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434933-759B-72D6-7A84-0497EBECF9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DC651FD-2DDD-44B4-F9C5-0C207EE221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9012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A8AE72F-4FAE-7E8E-B4A4-771F7EF0C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26148C0-40D9-9988-04A6-0A60BCA744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2CDCF1F-91EE-BF6A-8258-2BBD88CA32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2B8E6F9-F018-1710-9A08-46EA08B286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927DED9-A7DF-0344-16D1-CBA66B4F5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25379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C29567A-9C59-2137-49CE-CDB4D5C9A4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03D05C14-539E-8286-85F5-2BB9CC8EB3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89A18F9-B85E-E372-7D86-28EC0C496E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FBDCFA3-2E97-F318-9887-0ADB61218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9170F64-F1B0-41F9-C816-8E8B9D250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8AD40FD-126B-8E38-484E-81D5458AE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8129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53EE7E7-0F62-6EAC-347E-DEE0B1C515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67504E4-9BC8-0230-4328-1F6702902C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0432ACF-CE13-5D29-FED3-9B4A5B3D81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F42F0B2-3F33-26C8-D3B9-576F5E9FCB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0515F02-82DA-E780-499C-6011468462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B2FBD223-ACB7-450C-C4D9-05AE16B9C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1BF35446-D2F3-D45F-44CC-F65FDE4DD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F69D6149-56C9-6DE2-DABF-37A830FC19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7590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FD6CB65-9423-9A8F-D5A7-1CE472E4DA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15139DD7-930A-8920-D26D-A70A9CF465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6C36214-F9CF-243F-C584-3986F7A5A5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CE83180-3D36-9BFF-BB8F-5C103F242C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913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0554CA1F-5939-1525-C321-19CF9BC465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11F9A07-E0F6-5AAC-B209-6F76A2D9C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EF9CE6A-4E76-7324-654E-26BEA4CEA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8443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0ABA94A-5DEF-9656-942C-A234F4083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C257A57-950A-CCF9-1AA8-85F620C61D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99755AB-BB85-5212-DB3B-C16FCCC94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B097EA5-DCD4-EBF5-883B-A96F8ED5A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54C85E2-06E2-3C83-8E6F-5449BE2E2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25B1674-69CF-4952-D3CF-4CBB0E070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020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FA84561-CFC1-BD85-C30E-A79C05DDF4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5E3531C-E85E-8F63-0AD6-B8C0D78611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CFF96CE-57BE-A7BB-AC9A-F6981A9F46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9E961C4-10CA-A0A0-9715-A329D297D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7EEAD61-9F32-1314-15B8-C6AF89F89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C73D636-2A01-AB22-2324-04F0034DFB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96296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C5A5DE00-0389-E186-6A07-4F93AF40C2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5D0C0E9-9850-E4C6-0DEC-56A7A2E976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CEC098B-9CE8-D33A-8796-8F23FFBF84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9C443A-34F2-41BF-BD9B-141708D15732}" type="datetimeFigureOut">
              <a:rPr lang="fr-FR" smtClean="0"/>
              <a:t>09/0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8B31849-D271-833B-8BDD-FC7297B8F6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F018627-54DA-BB94-D8D0-45D2980F75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541CF2-7464-42D7-A29B-1389CACBE88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7238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3951DF2-94B3-4DE4-8123-8344D166774F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1031240" y="192912"/>
            <a:ext cx="10515600" cy="417195"/>
          </a:xfrm>
        </p:spPr>
        <p:txBody>
          <a:bodyPr>
            <a:normAutofit/>
          </a:bodyPr>
          <a:lstStyle/>
          <a:p>
            <a:pPr algn="ctr"/>
            <a:r>
              <a:rPr lang="en-US" sz="1600" b="1" dirty="0">
                <a:solidFill>
                  <a:schemeClr val="accent2">
                    <a:lumMod val="75000"/>
                  </a:schemeClr>
                </a:solidFill>
                <a:effectLst/>
                <a:latin typeface="+mn-lt"/>
                <a:ea typeface="Yu Mincho" panose="02020400000000000000" pitchFamily="18" charset="-128"/>
              </a:rPr>
              <a:t>PHU engagement process with faith-based organizations and racialized communities</a:t>
            </a:r>
            <a:endParaRPr lang="fr-FR" sz="1600" dirty="0">
              <a:solidFill>
                <a:schemeClr val="accent2">
                  <a:lumMod val="75000"/>
                </a:schemeClr>
              </a:solidFill>
              <a:latin typeface="+mn-lt"/>
            </a:endParaRPr>
          </a:p>
        </p:txBody>
      </p:sp>
      <p:grpSp>
        <p:nvGrpSpPr>
          <p:cNvPr id="33" name="Groupe 32">
            <a:extLst>
              <a:ext uri="{FF2B5EF4-FFF2-40B4-BE49-F238E27FC236}">
                <a16:creationId xmlns:a16="http://schemas.microsoft.com/office/drawing/2014/main" id="{B2CC18C9-6F05-0B6B-8649-9BDA378BCA83}"/>
              </a:ext>
            </a:extLst>
          </p:cNvPr>
          <p:cNvGrpSpPr/>
          <p:nvPr/>
        </p:nvGrpSpPr>
        <p:grpSpPr>
          <a:xfrm>
            <a:off x="462278" y="641437"/>
            <a:ext cx="11394440" cy="6023651"/>
            <a:chOff x="497836" y="650239"/>
            <a:chExt cx="11394440" cy="6023651"/>
          </a:xfrm>
        </p:grpSpPr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A27C9043-5D7F-BD5A-BD94-E82EECD15276}"/>
                </a:ext>
              </a:extLst>
            </p:cNvPr>
            <p:cNvSpPr/>
            <p:nvPr/>
          </p:nvSpPr>
          <p:spPr>
            <a:xfrm>
              <a:off x="497836" y="2366568"/>
              <a:ext cx="11394440" cy="4307322"/>
            </a:xfrm>
            <a:prstGeom prst="rect">
              <a:avLst/>
            </a:prstGeom>
            <a:solidFill>
              <a:schemeClr val="accent5">
                <a:lumMod val="5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83A1C26C-5D9D-1A65-70BA-2462D6886571}"/>
                </a:ext>
              </a:extLst>
            </p:cNvPr>
            <p:cNvSpPr/>
            <p:nvPr/>
          </p:nvSpPr>
          <p:spPr>
            <a:xfrm>
              <a:off x="497840" y="650239"/>
              <a:ext cx="11394436" cy="1397663"/>
            </a:xfrm>
            <a:prstGeom prst="rect">
              <a:avLst/>
            </a:prstGeom>
            <a:solidFill>
              <a:schemeClr val="accent1">
                <a:alpha val="46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" name="Groupe 2">
            <a:extLst>
              <a:ext uri="{FF2B5EF4-FFF2-40B4-BE49-F238E27FC236}">
                <a16:creationId xmlns:a16="http://schemas.microsoft.com/office/drawing/2014/main" id="{3F0433C3-5353-F2BF-0A6E-8842F6CC9C46}"/>
              </a:ext>
            </a:extLst>
          </p:cNvPr>
          <p:cNvGrpSpPr/>
          <p:nvPr/>
        </p:nvGrpSpPr>
        <p:grpSpPr>
          <a:xfrm>
            <a:off x="695960" y="653160"/>
            <a:ext cx="11069320" cy="1201594"/>
            <a:chOff x="695960" y="653160"/>
            <a:chExt cx="11069320" cy="1201594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E6E52D9D-9951-88CA-4141-3BB20F21E7C5}"/>
                </a:ext>
              </a:extLst>
            </p:cNvPr>
            <p:cNvSpPr/>
            <p:nvPr/>
          </p:nvSpPr>
          <p:spPr>
            <a:xfrm>
              <a:off x="695960" y="1114348"/>
              <a:ext cx="2585720" cy="740406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457200" indent="-457200" algn="ctr">
                <a:spcBef>
                  <a:spcPts val="600"/>
                </a:spcBef>
                <a:spcAft>
                  <a:spcPts val="600"/>
                </a:spcAft>
              </a:pPr>
              <a:r>
                <a:rPr lang="en-US" sz="1600" b="1" dirty="0">
                  <a:solidFill>
                    <a:schemeClr val="tx1"/>
                  </a:solidFill>
                  <a:effectLst/>
                  <a:ea typeface="Yu Gothic Light" panose="020B0300000000000000" pitchFamily="34" charset="-128"/>
                  <a:cs typeface="Times New Roman" panose="02020603050405020304" pitchFamily="18" charset="0"/>
                </a:rPr>
                <a:t>Use available data to analyze the situation. </a:t>
              </a:r>
              <a:endParaRPr lang="fr-FR" sz="1600" b="1" dirty="0">
                <a:solidFill>
                  <a:schemeClr val="tx1"/>
                </a:solidFill>
                <a:effectLst/>
                <a:ea typeface="Yu Gothic Light" panose="020B0300000000000000" pitchFamily="34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7A714511-2F8B-E976-170D-DE7CF78B3D64}"/>
                </a:ext>
              </a:extLst>
            </p:cNvPr>
            <p:cNvSpPr/>
            <p:nvPr/>
          </p:nvSpPr>
          <p:spPr>
            <a:xfrm>
              <a:off x="3416300" y="1093750"/>
              <a:ext cx="5552440" cy="740406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Reorganize internal structure or mechanism to support engagement with faith-based and ethno-racial organizations</a:t>
              </a:r>
              <a:endParaRPr lang="fr-FR" sz="1600" b="1" dirty="0">
                <a:solidFill>
                  <a:schemeClr val="tx1"/>
                </a:solidFill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AAD7C042-CDD6-B502-FCA5-BF8F8056AB69}"/>
                </a:ext>
              </a:extLst>
            </p:cNvPr>
            <p:cNvSpPr/>
            <p:nvPr/>
          </p:nvSpPr>
          <p:spPr>
            <a:xfrm>
              <a:off x="9083040" y="1100618"/>
              <a:ext cx="2682240" cy="708894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600" b="1" dirty="0">
                  <a:solidFill>
                    <a:schemeClr val="tx1"/>
                  </a:solidFill>
                </a:rPr>
                <a:t>Establish Working Groups and discussion tables within PHUs.</a:t>
              </a:r>
              <a:endParaRPr lang="fr-FR" sz="1600" b="1" dirty="0">
                <a:solidFill>
                  <a:schemeClr val="tx1"/>
                </a:solidFill>
              </a:endParaRPr>
            </a:p>
          </p:txBody>
        </p:sp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FDAB6EF0-8F5F-35D3-7018-5BD170D3BF24}"/>
                </a:ext>
              </a:extLst>
            </p:cNvPr>
            <p:cNvSpPr txBox="1"/>
            <p:nvPr/>
          </p:nvSpPr>
          <p:spPr>
            <a:xfrm>
              <a:off x="3416300" y="653160"/>
              <a:ext cx="726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chemeClr val="bg1"/>
                  </a:solidFill>
                </a:rPr>
                <a:t>Preparatory phase: learning process about FBOs and their needs.</a:t>
              </a:r>
            </a:p>
          </p:txBody>
        </p:sp>
      </p:grpSp>
      <p:grpSp>
        <p:nvGrpSpPr>
          <p:cNvPr id="4" name="Groupe 3">
            <a:extLst>
              <a:ext uri="{FF2B5EF4-FFF2-40B4-BE49-F238E27FC236}">
                <a16:creationId xmlns:a16="http://schemas.microsoft.com/office/drawing/2014/main" id="{6A22D02D-5D82-A95C-3362-E1CBB97AB238}"/>
              </a:ext>
            </a:extLst>
          </p:cNvPr>
          <p:cNvGrpSpPr/>
          <p:nvPr/>
        </p:nvGrpSpPr>
        <p:grpSpPr>
          <a:xfrm>
            <a:off x="648974" y="2731009"/>
            <a:ext cx="11135354" cy="943093"/>
            <a:chOff x="648974" y="2731009"/>
            <a:chExt cx="11135354" cy="943093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BD1C1725-1AA9-5984-6E43-044FA2AB1F45}"/>
                </a:ext>
              </a:extLst>
            </p:cNvPr>
            <p:cNvSpPr/>
            <p:nvPr/>
          </p:nvSpPr>
          <p:spPr>
            <a:xfrm>
              <a:off x="648974" y="2731009"/>
              <a:ext cx="3032762" cy="933838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>
                  <a:solidFill>
                    <a:schemeClr val="tx1"/>
                  </a:solidFill>
                </a:rPr>
                <a:t>Inform or consult to encourage interaction and open dialogue with FBOs and CBOs</a:t>
              </a:r>
              <a:endParaRPr lang="fr-FR" sz="1400" b="1" dirty="0">
                <a:solidFill>
                  <a:schemeClr val="tx1"/>
                </a:solidFill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E6709B66-9FC2-504D-68AC-1236757D8C49}"/>
                </a:ext>
              </a:extLst>
            </p:cNvPr>
            <p:cNvSpPr/>
            <p:nvPr/>
          </p:nvSpPr>
          <p:spPr>
            <a:xfrm>
              <a:off x="3665221" y="3444363"/>
              <a:ext cx="8119107" cy="229739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rtlCol="0" anchor="ctr"/>
            <a:lstStyle/>
            <a:p>
              <a:pPr>
                <a:spcBef>
                  <a:spcPts val="600"/>
                </a:spcBef>
                <a:spcAft>
                  <a:spcPts val="600"/>
                </a:spcAft>
              </a:pPr>
              <a:r>
                <a:rPr lang="en-US" sz="1400" b="1" dirty="0">
                  <a:solidFill>
                    <a:schemeClr val="tx1"/>
                  </a:solidFill>
                </a:rPr>
                <a:t>Regular outreach to engage faith communities and CBO leaders</a:t>
              </a:r>
              <a:endParaRPr lang="fr-FR" sz="1400" b="1" dirty="0">
                <a:solidFill>
                  <a:schemeClr val="tx1"/>
                </a:solidFill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56480221-7E7A-AF76-C1A5-FFC37B9EBDBF}"/>
                </a:ext>
              </a:extLst>
            </p:cNvPr>
            <p:cNvSpPr/>
            <p:nvPr/>
          </p:nvSpPr>
          <p:spPr>
            <a:xfrm>
              <a:off x="3665221" y="2731525"/>
              <a:ext cx="8112757" cy="229739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spcBef>
                  <a:spcPts val="600"/>
                </a:spcBef>
                <a:spcAft>
                  <a:spcPts val="600"/>
                </a:spcAft>
              </a:pPr>
              <a:r>
                <a:rPr lang="en-US" sz="1400" b="1" dirty="0">
                  <a:solidFill>
                    <a:schemeClr val="tx1"/>
                  </a:solidFill>
                </a:rPr>
                <a:t>Establish contacts with religious organizations for early and open dialogue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97EA2D65-1D0C-D5A2-8666-C1ECABB58C89}"/>
                </a:ext>
              </a:extLst>
            </p:cNvPr>
            <p:cNvSpPr/>
            <p:nvPr/>
          </p:nvSpPr>
          <p:spPr>
            <a:xfrm>
              <a:off x="3658871" y="3094780"/>
              <a:ext cx="8112757" cy="229740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>
                <a:spcBef>
                  <a:spcPts val="600"/>
                </a:spcBef>
                <a:spcAft>
                  <a:spcPts val="600"/>
                </a:spcAft>
              </a:pPr>
              <a:r>
                <a:rPr lang="en-US" sz="1400" b="1" dirty="0">
                  <a:solidFill>
                    <a:schemeClr val="tx1"/>
                  </a:solidFill>
                </a:rPr>
                <a:t>Maintain open dialogue , keeping them informed of new developments, their concerns and needs. </a:t>
              </a:r>
            </a:p>
          </p:txBody>
        </p:sp>
      </p:grpSp>
      <p:grpSp>
        <p:nvGrpSpPr>
          <p:cNvPr id="5" name="Groupe 4">
            <a:extLst>
              <a:ext uri="{FF2B5EF4-FFF2-40B4-BE49-F238E27FC236}">
                <a16:creationId xmlns:a16="http://schemas.microsoft.com/office/drawing/2014/main" id="{D8C3C7EB-A51D-CC98-75FB-79F9E669F0C2}"/>
              </a:ext>
            </a:extLst>
          </p:cNvPr>
          <p:cNvGrpSpPr/>
          <p:nvPr/>
        </p:nvGrpSpPr>
        <p:grpSpPr>
          <a:xfrm>
            <a:off x="619756" y="3968778"/>
            <a:ext cx="11145522" cy="786102"/>
            <a:chOff x="619756" y="3968778"/>
            <a:chExt cx="11145522" cy="786102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CA834573-2394-8DE7-9F62-EB136A54624B}"/>
                </a:ext>
              </a:extLst>
            </p:cNvPr>
            <p:cNvSpPr/>
            <p:nvPr/>
          </p:nvSpPr>
          <p:spPr>
            <a:xfrm>
              <a:off x="3646171" y="3968778"/>
              <a:ext cx="8119107" cy="203048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b="1" dirty="0">
                  <a:solidFill>
                    <a:schemeClr val="tx1"/>
                  </a:solidFill>
                </a:rPr>
                <a:t>Work with FBOs to identify their needs and plan together how best to support them.</a:t>
              </a:r>
              <a:endParaRPr lang="fr-FR" sz="1400" b="1" dirty="0">
                <a:solidFill>
                  <a:schemeClr val="tx1"/>
                </a:solidFill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97E4D06-AB2A-E96F-E61D-B2F04A87C177}"/>
                </a:ext>
              </a:extLst>
            </p:cNvPr>
            <p:cNvSpPr/>
            <p:nvPr/>
          </p:nvSpPr>
          <p:spPr>
            <a:xfrm>
              <a:off x="619756" y="3968779"/>
              <a:ext cx="3032762" cy="786101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>
                  <a:solidFill>
                    <a:schemeClr val="tx1"/>
                  </a:solidFill>
                </a:rPr>
                <a:t>Involving faith-based and community organizations in planning </a:t>
              </a:r>
              <a:endParaRPr lang="fr-FR" sz="1400" b="1" dirty="0">
                <a:solidFill>
                  <a:schemeClr val="tx1"/>
                </a:solidFill>
              </a:endParaRP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B3EA8F42-615C-6BAB-0D61-E44E4582A530}"/>
                </a:ext>
              </a:extLst>
            </p:cNvPr>
            <p:cNvSpPr/>
            <p:nvPr/>
          </p:nvSpPr>
          <p:spPr>
            <a:xfrm>
              <a:off x="3652518" y="4485750"/>
              <a:ext cx="8112760" cy="269129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rtlCol="0" anchor="ctr"/>
            <a:lstStyle/>
            <a:p>
              <a:r>
                <a:rPr lang="en-US" sz="1400" b="1" dirty="0">
                  <a:solidFill>
                    <a:schemeClr val="tx1"/>
                  </a:solidFill>
                </a:rPr>
                <a:t>Obtain permission and involve FBOs leaders to set up vaccination clinics in places of worship</a:t>
              </a:r>
              <a:endParaRPr lang="fr-FR" sz="1400" b="1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0B6B462A-06CD-2B61-489F-6CCDA9208931}"/>
              </a:ext>
            </a:extLst>
          </p:cNvPr>
          <p:cNvGrpSpPr/>
          <p:nvPr/>
        </p:nvGrpSpPr>
        <p:grpSpPr>
          <a:xfrm>
            <a:off x="619759" y="4955098"/>
            <a:ext cx="11158219" cy="1449596"/>
            <a:chOff x="619759" y="5072452"/>
            <a:chExt cx="11158219" cy="1332241"/>
          </a:xfrm>
        </p:grpSpPr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D5806A37-21EE-6430-258B-44EE1DC788D4}"/>
                </a:ext>
              </a:extLst>
            </p:cNvPr>
            <p:cNvSpPr/>
            <p:nvPr/>
          </p:nvSpPr>
          <p:spPr>
            <a:xfrm>
              <a:off x="619759" y="5082611"/>
              <a:ext cx="3026411" cy="1322082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>
                  <a:solidFill>
                    <a:schemeClr val="tx1"/>
                  </a:solidFill>
                </a:rPr>
                <a:t>Collaborate with FBOs, religious leaders, and ethno-racial communities to deliver services</a:t>
              </a:r>
              <a:endParaRPr lang="fr-FR" sz="1400" b="1" dirty="0">
                <a:solidFill>
                  <a:schemeClr val="tx1"/>
                </a:solidFill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6D3853BE-544D-AB3B-8BD4-BC563FA453C9}"/>
                </a:ext>
              </a:extLst>
            </p:cNvPr>
            <p:cNvSpPr/>
            <p:nvPr/>
          </p:nvSpPr>
          <p:spPr>
            <a:xfrm>
              <a:off x="3646170" y="5608303"/>
              <a:ext cx="8106407" cy="224878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b="1" dirty="0">
                  <a:solidFill>
                    <a:schemeClr val="tx1"/>
                  </a:solidFill>
                </a:rPr>
                <a:t>PHUs Worked discreetly to respect communities' need for </a:t>
              </a:r>
              <a:r>
                <a:rPr lang="en-US" sz="1400" b="1" dirty="0" err="1">
                  <a:solidFill>
                    <a:schemeClr val="tx1"/>
                  </a:solidFill>
                </a:rPr>
                <a:t>reflexion</a:t>
              </a:r>
              <a:r>
                <a:rPr lang="en-US" sz="1400" b="1" dirty="0">
                  <a:solidFill>
                    <a:schemeClr val="tx1"/>
                  </a:solidFill>
                </a:rPr>
                <a:t>.</a:t>
              </a:r>
              <a:endParaRPr lang="fr-FR" sz="1400" b="1" dirty="0">
                <a:solidFill>
                  <a:schemeClr val="tx1"/>
                </a:solidFill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7BE6F114-F14D-EDEC-FC3B-FB3C071EFBEC}"/>
                </a:ext>
              </a:extLst>
            </p:cNvPr>
            <p:cNvSpPr/>
            <p:nvPr/>
          </p:nvSpPr>
          <p:spPr>
            <a:xfrm>
              <a:off x="3575058" y="5072452"/>
              <a:ext cx="8202920" cy="420894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b="1" dirty="0">
                  <a:solidFill>
                    <a:schemeClr val="tx1"/>
                  </a:solidFill>
                </a:rPr>
                <a:t>Work directly with FBOs to inform communities about Covid and  delivery vaccine in worship, FBOs health center  </a:t>
              </a:r>
              <a:endParaRPr lang="fr-FR" sz="1400" b="1" dirty="0">
                <a:solidFill>
                  <a:schemeClr val="tx1"/>
                </a:solidFill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2EB4652F-7A59-8068-4510-6D8155EEB80D}"/>
                </a:ext>
              </a:extLst>
            </p:cNvPr>
            <p:cNvSpPr/>
            <p:nvPr/>
          </p:nvSpPr>
          <p:spPr>
            <a:xfrm>
              <a:off x="3639819" y="5937154"/>
              <a:ext cx="8119107" cy="467539"/>
            </a:xfrm>
            <a:prstGeom prst="rect">
              <a:avLst/>
            </a:prstGeom>
            <a:solidFill>
              <a:schemeClr val="accent5">
                <a:lumMod val="20000"/>
                <a:lumOff val="80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40" tIns="45720" rIns="91440" bIns="45720" rtlCol="0" anchor="ctr"/>
            <a:lstStyle/>
            <a:p>
              <a:r>
                <a:rPr lang="en-US" sz="1400" b="1" dirty="0">
                  <a:solidFill>
                    <a:schemeClr val="tx1"/>
                  </a:solidFill>
                </a:rPr>
                <a:t>PHUs relied on intermediaries such as  nurses and emergency medical  services for vaccine delivery to groups made structurally vulnerable</a:t>
              </a:r>
              <a:endParaRPr lang="fr-FR" sz="1400" b="1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9" name="Groupe 38">
            <a:extLst>
              <a:ext uri="{FF2B5EF4-FFF2-40B4-BE49-F238E27FC236}">
                <a16:creationId xmlns:a16="http://schemas.microsoft.com/office/drawing/2014/main" id="{22356D02-AD3C-153B-88B3-776A851E8434}"/>
              </a:ext>
            </a:extLst>
          </p:cNvPr>
          <p:cNvGrpSpPr/>
          <p:nvPr/>
        </p:nvGrpSpPr>
        <p:grpSpPr>
          <a:xfrm>
            <a:off x="109350" y="596780"/>
            <a:ext cx="6057770" cy="6136133"/>
            <a:chOff x="109350" y="596780"/>
            <a:chExt cx="6057770" cy="6136133"/>
          </a:xfrm>
        </p:grpSpPr>
        <p:sp>
          <p:nvSpPr>
            <p:cNvPr id="32" name="Flèche : double flèche verticale 31">
              <a:extLst>
                <a:ext uri="{FF2B5EF4-FFF2-40B4-BE49-F238E27FC236}">
                  <a16:creationId xmlns:a16="http://schemas.microsoft.com/office/drawing/2014/main" id="{F3A787C1-290A-4874-2FD8-F7A0D3EFD0D9}"/>
                </a:ext>
              </a:extLst>
            </p:cNvPr>
            <p:cNvSpPr/>
            <p:nvPr/>
          </p:nvSpPr>
          <p:spPr>
            <a:xfrm>
              <a:off x="1863850" y="3550971"/>
              <a:ext cx="330710" cy="445187"/>
            </a:xfrm>
            <a:prstGeom prst="upDownArrow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4" name="Flèche : double flèche verticale 33">
              <a:extLst>
                <a:ext uri="{FF2B5EF4-FFF2-40B4-BE49-F238E27FC236}">
                  <a16:creationId xmlns:a16="http://schemas.microsoft.com/office/drawing/2014/main" id="{9842B073-50EB-FFA8-63B0-3FE4ACF844BE}"/>
                </a:ext>
              </a:extLst>
            </p:cNvPr>
            <p:cNvSpPr/>
            <p:nvPr/>
          </p:nvSpPr>
          <p:spPr>
            <a:xfrm>
              <a:off x="5852160" y="1987624"/>
              <a:ext cx="314960" cy="425235"/>
            </a:xfrm>
            <a:prstGeom prst="upDownArrow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5" name="Flèche : double flèche verticale 34">
              <a:extLst>
                <a:ext uri="{FF2B5EF4-FFF2-40B4-BE49-F238E27FC236}">
                  <a16:creationId xmlns:a16="http://schemas.microsoft.com/office/drawing/2014/main" id="{35A020AE-0ABE-DA1F-142E-FDB2E58E9F50}"/>
                </a:ext>
              </a:extLst>
            </p:cNvPr>
            <p:cNvSpPr/>
            <p:nvPr/>
          </p:nvSpPr>
          <p:spPr>
            <a:xfrm>
              <a:off x="1808738" y="4632453"/>
              <a:ext cx="330710" cy="445187"/>
            </a:xfrm>
            <a:prstGeom prst="upDownArrow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Flèche : double flèche verticale 35">
              <a:extLst>
                <a:ext uri="{FF2B5EF4-FFF2-40B4-BE49-F238E27FC236}">
                  <a16:creationId xmlns:a16="http://schemas.microsoft.com/office/drawing/2014/main" id="{011D106B-EF95-FA7D-96CD-189780A761E3}"/>
                </a:ext>
              </a:extLst>
            </p:cNvPr>
            <p:cNvSpPr/>
            <p:nvPr/>
          </p:nvSpPr>
          <p:spPr>
            <a:xfrm>
              <a:off x="109350" y="596780"/>
              <a:ext cx="330710" cy="6136133"/>
            </a:xfrm>
            <a:prstGeom prst="upDownArrow">
              <a:avLst/>
            </a:prstGeom>
            <a:solidFill>
              <a:schemeClr val="bg2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293420930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2" Type="http://schemas.microsoft.com/office/2011/relationships/webextension" Target="webextension2.xml"/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525" row="2">
    <wetp:webextensionref xmlns:r="http://schemas.openxmlformats.org/officeDocument/2006/relationships" r:id="rId1"/>
  </wetp:taskpane>
  <wetp:taskpane dockstate="right" visibility="0" width="525" row="3">
    <wetp:webextensionref xmlns:r="http://schemas.openxmlformats.org/officeDocument/2006/relationships" r:id="rId2"/>
  </wetp:taskpane>
</wetp:taskpanes>
</file>

<file path=ppt/webextensions/webextension1.xml><?xml version="1.0" encoding="utf-8"?>
<we:webextension xmlns:we="http://schemas.microsoft.com/office/webextensions/webextension/2010/11" id="{3DC332EE-77E3-413F-B695-CC9D1A7D249C}">
  <we:reference id="wa200005566" version="1.0.0.0" store="fr-FR" storeType="OMEX"/>
  <we:alternateReferences>
    <we:reference id="wa200005566" version="1.0.0.0" store="wa200005566" storeType="OMEX"/>
  </we:alternateReferences>
  <we:properties/>
  <we:bindings/>
  <we:snapshot xmlns:r="http://schemas.openxmlformats.org/officeDocument/2006/relationships"/>
</we:webextension>
</file>

<file path=ppt/webextensions/webextension2.xml><?xml version="1.0" encoding="utf-8"?>
<we:webextension xmlns:we="http://schemas.microsoft.com/office/webextensions/webextension/2010/11" id="{7693EBB1-EB30-456C-97B1-CEC9F7789C33}">
  <we:reference id="wa104380526" version="1.0.33.0" store="fr-FR" storeType="OMEX"/>
  <we:alternateReferences>
    <we:reference id="wa104380526" version="1.0.33.0" store="wa104380526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otalTime>366</TotalTime>
  <Words>197</Words>
  <Application>Microsoft Office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HU engagement process with faith-based organizations and racialized communiti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adidiatou Kadio</dc:creator>
  <cp:lastModifiedBy>Kadidiatou</cp:lastModifiedBy>
  <cp:revision>23</cp:revision>
  <dcterms:created xsi:type="dcterms:W3CDTF">2023-10-31T22:43:51Z</dcterms:created>
  <dcterms:modified xsi:type="dcterms:W3CDTF">2024-01-09T22:19:58Z</dcterms:modified>
</cp:coreProperties>
</file>